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538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-330" y="-59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80B67-FCE5-4941-AAD2-0F53589A9A6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E76A7-4AC5-46BB-9DAE-466E14E6F6C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5533" y="1733179"/>
            <a:ext cx="10611268" cy="2450351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061882" y="4249271"/>
            <a:ext cx="7392894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moderate-to-vigorous physical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ity. [13,17-18,35,40,45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83427" y="1637551"/>
            <a:ext cx="9225146" cy="239058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164840" y="4147820"/>
            <a:ext cx="61804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light physical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ity. [13,18,35-36,38,41-43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68435" y="2031479"/>
            <a:ext cx="8647248" cy="2056427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944906" y="4147671"/>
            <a:ext cx="6302188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moderate physical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ity. [13,36,38,41-43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73535" y="1924275"/>
            <a:ext cx="8444930" cy="2229372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944906" y="4147671"/>
            <a:ext cx="6302188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vigorous physical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ity. [13,36,38,41-43,45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78300" y="1894300"/>
            <a:ext cx="8777123" cy="227727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712210" y="4171315"/>
            <a:ext cx="52679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step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nt. [12,15-16,18,36-37,43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92876" y="2063137"/>
            <a:ext cx="8633059" cy="166020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265170" y="3759200"/>
            <a:ext cx="58477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sedentary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havior. [13,35,38,42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24285" y="1773418"/>
            <a:ext cx="8143429" cy="2003712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987675" y="3830955"/>
            <a:ext cx="62160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est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of body max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. [13,34,36,39-40,42,45]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4</Words>
  <Application>WPS 演示</Application>
  <PresentationFormat>Custom</PresentationFormat>
  <Paragraphs>14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7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ijia li</dc:creator>
  <cp:lastModifiedBy>Lisy 李思佳</cp:lastModifiedBy>
  <cp:revision>17</cp:revision>
  <dcterms:created xsi:type="dcterms:W3CDTF">2025-01-17T09:14:00Z</dcterms:created>
  <dcterms:modified xsi:type="dcterms:W3CDTF">2025-07-05T11:53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C48469F50F94FEAADB5B0BAA97B5FFA_12</vt:lpwstr>
  </property>
  <property fmtid="{D5CDD505-2E9C-101B-9397-08002B2CF9AE}" pid="3" name="KSOProductBuildVer">
    <vt:lpwstr>2052-12.1.0.21915</vt:lpwstr>
  </property>
</Properties>
</file>